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541119" y="6381328"/>
            <a:ext cx="39100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8 Fig. Example results in an output file in text format. 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13905" y="242466"/>
            <a:ext cx="850583" cy="6126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8401" y="232943"/>
            <a:ext cx="832485" cy="61441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71346" y="232943"/>
            <a:ext cx="823436" cy="61441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4948" y="228178"/>
            <a:ext cx="823436" cy="6153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7144" y="232943"/>
            <a:ext cx="841534" cy="61441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3728" y="237705"/>
            <a:ext cx="2198846" cy="61350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46798" y="145955"/>
            <a:ext cx="13203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Cambria" pitchFamily="18" charset="0"/>
              </a:rPr>
              <a:t>Barcode length and number of barcodes</a:t>
            </a:r>
            <a:endParaRPr lang="ko-KR" altLang="en-US" sz="1200" dirty="0">
              <a:latin typeface="Cambria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5496" y="982469"/>
            <a:ext cx="13316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Cambria" pitchFamily="18" charset="0"/>
              </a:rPr>
              <a:t>Total penalty scores of this barcode set</a:t>
            </a:r>
            <a:endParaRPr lang="ko-KR" altLang="en-US" sz="1200" dirty="0">
              <a:latin typeface="Cambria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5497" y="3781489"/>
            <a:ext cx="13316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Cambria" pitchFamily="18" charset="0"/>
              </a:rPr>
              <a:t>Selected barcode sequences (alphabetically ordered)</a:t>
            </a:r>
            <a:endParaRPr lang="ko-KR" altLang="en-US" sz="1200" dirty="0">
              <a:latin typeface="Cambria" pitchFamily="18" charset="0"/>
            </a:endParaRPr>
          </a:p>
        </p:txBody>
      </p:sp>
      <p:cxnSp>
        <p:nvCxnSpPr>
          <p:cNvPr id="5" name="직선 화살표 연결선 4"/>
          <p:cNvCxnSpPr>
            <a:stCxn id="10" idx="1"/>
            <a:endCxn id="17" idx="3"/>
          </p:cNvCxnSpPr>
          <p:nvPr/>
        </p:nvCxnSpPr>
        <p:spPr>
          <a:xfrm flipH="1">
            <a:off x="1367136" y="358274"/>
            <a:ext cx="515148" cy="11084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화살표 연결선 6"/>
          <p:cNvCxnSpPr>
            <a:stCxn id="24" idx="1"/>
            <a:endCxn id="18" idx="3"/>
          </p:cNvCxnSpPr>
          <p:nvPr/>
        </p:nvCxnSpPr>
        <p:spPr>
          <a:xfrm flipH="1">
            <a:off x="1367136" y="900373"/>
            <a:ext cx="515148" cy="40526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화살표 연결선 8"/>
          <p:cNvCxnSpPr>
            <a:stCxn id="19" idx="3"/>
            <a:endCxn id="25" idx="1"/>
          </p:cNvCxnSpPr>
          <p:nvPr/>
        </p:nvCxnSpPr>
        <p:spPr>
          <a:xfrm flipV="1">
            <a:off x="1367137" y="3828212"/>
            <a:ext cx="515147" cy="368776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왼쪽 중괄호 9"/>
          <p:cNvSpPr/>
          <p:nvPr/>
        </p:nvSpPr>
        <p:spPr>
          <a:xfrm>
            <a:off x="1882284" y="237803"/>
            <a:ext cx="222194" cy="24094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왼쪽 중괄호 23"/>
          <p:cNvSpPr/>
          <p:nvPr/>
        </p:nvSpPr>
        <p:spPr>
          <a:xfrm>
            <a:off x="1882284" y="492646"/>
            <a:ext cx="222194" cy="81545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왼쪽 중괄호 24"/>
          <p:cNvSpPr/>
          <p:nvPr/>
        </p:nvSpPr>
        <p:spPr>
          <a:xfrm>
            <a:off x="1882284" y="1325474"/>
            <a:ext cx="222194" cy="5005476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0105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6</TotalTime>
  <Words>3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mbria</vt:lpstr>
      <vt:lpstr>Office 테마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42:35Z</dcterms:modified>
</cp:coreProperties>
</file>